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14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4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>
        <p:scale>
          <a:sx n="125" d="100"/>
          <a:sy n="125" d="100"/>
        </p:scale>
        <p:origin x="2130" y="90"/>
      </p:cViewPr>
      <p:guideLst>
        <p:guide orient="horz" pos="384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s-ES"/>
              <a:t>Haga clic para modificar el estilo de subtítulo del patró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756DE-4589-40F3-AF01-BCB71D2E53CC}" type="datetimeFigureOut">
              <a:rPr lang="es-ES" smtClean="0"/>
              <a:t>29/08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67B736-4413-411F-AAB9-30639585CA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24896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756DE-4589-40F3-AF01-BCB71D2E53CC}" type="datetimeFigureOut">
              <a:rPr lang="es-ES" smtClean="0"/>
              <a:t>29/08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67B736-4413-411F-AAB9-30639585CA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942553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756DE-4589-40F3-AF01-BCB71D2E53CC}" type="datetimeFigureOut">
              <a:rPr lang="es-ES" smtClean="0"/>
              <a:t>29/08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67B736-4413-411F-AAB9-30639585CA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912679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756DE-4589-40F3-AF01-BCB71D2E53CC}" type="datetimeFigureOut">
              <a:rPr lang="es-ES" smtClean="0"/>
              <a:t>29/08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67B736-4413-411F-AAB9-30639585CA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581999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756DE-4589-40F3-AF01-BCB71D2E53CC}" type="datetimeFigureOut">
              <a:rPr lang="es-ES" smtClean="0"/>
              <a:t>29/08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67B736-4413-411F-AAB9-30639585CA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082712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756DE-4589-40F3-AF01-BCB71D2E53CC}" type="datetimeFigureOut">
              <a:rPr lang="es-ES" smtClean="0"/>
              <a:t>29/08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67B736-4413-411F-AAB9-30639585CA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234139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756DE-4589-40F3-AF01-BCB71D2E53CC}" type="datetimeFigureOut">
              <a:rPr lang="es-ES" smtClean="0"/>
              <a:t>29/08/2023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67B736-4413-411F-AAB9-30639585CA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72980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756DE-4589-40F3-AF01-BCB71D2E53CC}" type="datetimeFigureOut">
              <a:rPr lang="es-ES" smtClean="0"/>
              <a:t>29/08/2023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67B736-4413-411F-AAB9-30639585CA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677921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756DE-4589-40F3-AF01-BCB71D2E53CC}" type="datetimeFigureOut">
              <a:rPr lang="es-ES" smtClean="0"/>
              <a:t>29/08/2023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67B736-4413-411F-AAB9-30639585CA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881477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756DE-4589-40F3-AF01-BCB71D2E53CC}" type="datetimeFigureOut">
              <a:rPr lang="es-ES" smtClean="0"/>
              <a:t>29/08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67B736-4413-411F-AAB9-30639585CA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003296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s-ES"/>
              <a:t>Haga clic en el icono para agregar una ima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1756DE-4589-40F3-AF01-BCB71D2E53CC}" type="datetimeFigureOut">
              <a:rPr lang="es-ES" smtClean="0"/>
              <a:t>29/08/2023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667B736-4413-411F-AAB9-30639585CA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083062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1756DE-4589-40F3-AF01-BCB71D2E53CC}" type="datetimeFigureOut">
              <a:rPr lang="es-ES" smtClean="0"/>
              <a:t>29/08/2023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7B736-4413-411F-AAB9-30639585CA01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526520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2">
            <a:extLst>
              <a:ext uri="{FF2B5EF4-FFF2-40B4-BE49-F238E27FC236}">
                <a16:creationId xmlns:a16="http://schemas.microsoft.com/office/drawing/2014/main" id="{7884E524-C38E-1EEA-C013-D3AEFCA02A6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39575" y="9387852"/>
            <a:ext cx="2264400" cy="221007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3" name="Imagen 12" descr="Gráfico, Gráfico de líneas&#10;&#10;Descripción generada automáticamente">
            <a:extLst>
              <a:ext uri="{FF2B5EF4-FFF2-40B4-BE49-F238E27FC236}">
                <a16:creationId xmlns:a16="http://schemas.microsoft.com/office/drawing/2014/main" id="{63308E35-BF36-3655-4DC2-EC7D16DB9F12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71310" y="9433244"/>
            <a:ext cx="2264400" cy="2119294"/>
          </a:xfrm>
          <a:prstGeom prst="rect">
            <a:avLst/>
          </a:prstGeom>
          <a:noFill/>
        </p:spPr>
      </p:pic>
      <p:pic>
        <p:nvPicPr>
          <p:cNvPr id="5" name="Imagen 4">
            <a:extLst>
              <a:ext uri="{FF2B5EF4-FFF2-40B4-BE49-F238E27FC236}">
                <a16:creationId xmlns:a16="http://schemas.microsoft.com/office/drawing/2014/main" id="{B508EA06-76F8-92C7-D6F8-BF08B9D9F831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71310" y="4663690"/>
            <a:ext cx="2264400" cy="22172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026" name="Picture 2">
            <a:extLst>
              <a:ext uri="{FF2B5EF4-FFF2-40B4-BE49-F238E27FC236}">
                <a16:creationId xmlns:a16="http://schemas.microsoft.com/office/drawing/2014/main" id="{43AF63B3-E491-4077-9FA1-FBBFF295AF8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71310" y="219050"/>
            <a:ext cx="2264400" cy="22172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7" name="Picture 3">
            <a:extLst>
              <a:ext uri="{FF2B5EF4-FFF2-40B4-BE49-F238E27FC236}">
                <a16:creationId xmlns:a16="http://schemas.microsoft.com/office/drawing/2014/main" id="{AF1AA607-28BC-F48A-36BE-2BF12AC9794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317052" y="219050"/>
            <a:ext cx="2264400" cy="22172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8" name="Picture 4">
            <a:extLst>
              <a:ext uri="{FF2B5EF4-FFF2-40B4-BE49-F238E27FC236}">
                <a16:creationId xmlns:a16="http://schemas.microsoft.com/office/drawing/2014/main" id="{272D26C2-E93F-8723-1291-AE7D460660BA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539575" y="219050"/>
            <a:ext cx="2264400" cy="22172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9" name="Picture 5">
            <a:extLst>
              <a:ext uri="{FF2B5EF4-FFF2-40B4-BE49-F238E27FC236}">
                <a16:creationId xmlns:a16="http://schemas.microsoft.com/office/drawing/2014/main" id="{2BD8C9A5-7E37-7D2A-FDA0-FEBD456B6AF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171310" y="2372759"/>
            <a:ext cx="2264400" cy="22172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" name="Imagen 1">
            <a:extLst>
              <a:ext uri="{FF2B5EF4-FFF2-40B4-BE49-F238E27FC236}">
                <a16:creationId xmlns:a16="http://schemas.microsoft.com/office/drawing/2014/main" id="{1F5C8356-FD9E-109F-01DC-81EEF4FE76B3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317052" y="2372759"/>
            <a:ext cx="2264400" cy="2217225"/>
          </a:xfrm>
          <a:prstGeom prst="rect">
            <a:avLst/>
          </a:prstGeom>
          <a:noFill/>
          <a:ln>
            <a:noFill/>
          </a:ln>
        </p:spPr>
      </p:pic>
      <p:pic>
        <p:nvPicPr>
          <p:cNvPr id="1030" name="Picture 6">
            <a:extLst>
              <a:ext uri="{FF2B5EF4-FFF2-40B4-BE49-F238E27FC236}">
                <a16:creationId xmlns:a16="http://schemas.microsoft.com/office/drawing/2014/main" id="{BE57F8DC-CE00-A4E3-CBD2-4983CDF85ED1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539575" y="2372759"/>
            <a:ext cx="2264400" cy="221722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6" name="Imagen 5">
            <a:extLst>
              <a:ext uri="{FF2B5EF4-FFF2-40B4-BE49-F238E27FC236}">
                <a16:creationId xmlns:a16="http://schemas.microsoft.com/office/drawing/2014/main" id="{2340957D-7367-AAFF-D5E1-B17BED01AFDC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317052" y="4712654"/>
            <a:ext cx="2264400" cy="2119296"/>
          </a:xfrm>
          <a:prstGeom prst="rect">
            <a:avLst/>
          </a:prstGeom>
          <a:noFill/>
        </p:spPr>
      </p:pic>
      <p:pic>
        <p:nvPicPr>
          <p:cNvPr id="7" name="Imagen 6">
            <a:extLst>
              <a:ext uri="{FF2B5EF4-FFF2-40B4-BE49-F238E27FC236}">
                <a16:creationId xmlns:a16="http://schemas.microsoft.com/office/drawing/2014/main" id="{9F0B9815-9608-D7A6-3BCE-F0A6A798DFF1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539575" y="4712654"/>
            <a:ext cx="2264400" cy="2119296"/>
          </a:xfrm>
          <a:prstGeom prst="rect">
            <a:avLst/>
          </a:prstGeom>
          <a:noFill/>
        </p:spPr>
      </p:pic>
      <p:pic>
        <p:nvPicPr>
          <p:cNvPr id="9" name="Picture 7">
            <a:extLst>
              <a:ext uri="{FF2B5EF4-FFF2-40B4-BE49-F238E27FC236}">
                <a16:creationId xmlns:a16="http://schemas.microsoft.com/office/drawing/2014/main" id="{5C76E3FC-4914-F942-3C24-860B8D6D5A6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71310" y="7107915"/>
            <a:ext cx="2264400" cy="22172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" name="Imagen 9">
            <a:extLst>
              <a:ext uri="{FF2B5EF4-FFF2-40B4-BE49-F238E27FC236}">
                <a16:creationId xmlns:a16="http://schemas.microsoft.com/office/drawing/2014/main" id="{2619EC32-4CDD-E05F-9FBD-36B6C3EDB7C9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17052" y="7107916"/>
            <a:ext cx="2264400" cy="2217224"/>
          </a:xfrm>
          <a:prstGeom prst="rect">
            <a:avLst/>
          </a:prstGeom>
          <a:noFill/>
          <a:ln>
            <a:noFill/>
          </a:ln>
        </p:spPr>
      </p:pic>
      <p:pic>
        <p:nvPicPr>
          <p:cNvPr id="11" name="Picture 8">
            <a:extLst>
              <a:ext uri="{FF2B5EF4-FFF2-40B4-BE49-F238E27FC236}">
                <a16:creationId xmlns:a16="http://schemas.microsoft.com/office/drawing/2014/main" id="{9B88E5D3-ADFE-13E3-DAF3-29427612F46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39575" y="7107915"/>
            <a:ext cx="2264400" cy="22172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4" name="Imagen 13">
            <a:extLst>
              <a:ext uri="{FF2B5EF4-FFF2-40B4-BE49-F238E27FC236}">
                <a16:creationId xmlns:a16="http://schemas.microsoft.com/office/drawing/2014/main" id="{1486FF53-D55C-B0FB-C428-1E989F90469E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2317052" y="9433244"/>
            <a:ext cx="2264400" cy="2119294"/>
          </a:xfrm>
          <a:prstGeom prst="rect">
            <a:avLst/>
          </a:prstGeom>
          <a:noFill/>
        </p:spPr>
      </p:pic>
      <p:sp>
        <p:nvSpPr>
          <p:cNvPr id="3" name="CuadroTexto 2">
            <a:extLst>
              <a:ext uri="{FF2B5EF4-FFF2-40B4-BE49-F238E27FC236}">
                <a16:creationId xmlns:a16="http://schemas.microsoft.com/office/drawing/2014/main" id="{D6681C4A-89BF-060D-3A27-B7E704A2D611}"/>
              </a:ext>
            </a:extLst>
          </p:cNvPr>
          <p:cNvSpPr txBox="1"/>
          <p:nvPr/>
        </p:nvSpPr>
        <p:spPr>
          <a:xfrm>
            <a:off x="85178" y="229655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4" name="CuadroTexto 3">
            <a:extLst>
              <a:ext uri="{FF2B5EF4-FFF2-40B4-BE49-F238E27FC236}">
                <a16:creationId xmlns:a16="http://schemas.microsoft.com/office/drawing/2014/main" id="{CD9D6F6C-0D90-8F6B-9F05-9A8D4D1DE41F}"/>
              </a:ext>
            </a:extLst>
          </p:cNvPr>
          <p:cNvSpPr txBox="1"/>
          <p:nvPr/>
        </p:nvSpPr>
        <p:spPr>
          <a:xfrm>
            <a:off x="89987" y="4561017"/>
            <a:ext cx="300082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8" name="CuadroTexto 7">
            <a:extLst>
              <a:ext uri="{FF2B5EF4-FFF2-40B4-BE49-F238E27FC236}">
                <a16:creationId xmlns:a16="http://schemas.microsoft.com/office/drawing/2014/main" id="{6B8A92F3-99A7-D906-FF6C-681CF4511801}"/>
              </a:ext>
            </a:extLst>
          </p:cNvPr>
          <p:cNvSpPr txBox="1"/>
          <p:nvPr/>
        </p:nvSpPr>
        <p:spPr>
          <a:xfrm>
            <a:off x="85178" y="6946981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2" name="CuadroTexto 11">
            <a:extLst>
              <a:ext uri="{FF2B5EF4-FFF2-40B4-BE49-F238E27FC236}">
                <a16:creationId xmlns:a16="http://schemas.microsoft.com/office/drawing/2014/main" id="{2FF0CB3F-447F-10BF-19F4-CD17420C4FCB}"/>
              </a:ext>
            </a:extLst>
          </p:cNvPr>
          <p:cNvSpPr txBox="1"/>
          <p:nvPr/>
        </p:nvSpPr>
        <p:spPr>
          <a:xfrm>
            <a:off x="85178" y="9248747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</a:p>
        </p:txBody>
      </p:sp>
      <p:sp>
        <p:nvSpPr>
          <p:cNvPr id="15" name="Rectángulo 14">
            <a:extLst>
              <a:ext uri="{FF2B5EF4-FFF2-40B4-BE49-F238E27FC236}">
                <a16:creationId xmlns:a16="http://schemas.microsoft.com/office/drawing/2014/main" id="{0BDAA86F-0AED-AD0B-8771-853E5CD1338F}"/>
              </a:ext>
            </a:extLst>
          </p:cNvPr>
          <p:cNvSpPr/>
          <p:nvPr/>
        </p:nvSpPr>
        <p:spPr>
          <a:xfrm>
            <a:off x="0" y="11541561"/>
            <a:ext cx="6837449" cy="48564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450"/>
              </a:spcAft>
            </a:pPr>
            <a:r>
              <a:rPr lang="en-US" sz="9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S2. Effect interaction plots between the presence of diabetes and sex for pathological markers of AS in AVs from AS patients. </a:t>
            </a:r>
            <a:r>
              <a:rPr lang="en-US" sz="9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) oxidative stress, (B) inflammatory, (C) calcification and (D) metabolic markers, and (E) </a:t>
            </a:r>
            <a:r>
              <a:rPr lang="el-GR" sz="9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α</a:t>
            </a:r>
            <a:r>
              <a:rPr lang="es-ES" sz="9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SMA</a:t>
            </a:r>
            <a:r>
              <a:rPr lang="en-US" sz="9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endParaRPr lang="es-ES" sz="825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6" name="CuadroTexto 15">
            <a:extLst>
              <a:ext uri="{FF2B5EF4-FFF2-40B4-BE49-F238E27FC236}">
                <a16:creationId xmlns:a16="http://schemas.microsoft.com/office/drawing/2014/main" id="{623BE5F5-8E2F-F9F4-1381-ADC0162C4731}"/>
              </a:ext>
            </a:extLst>
          </p:cNvPr>
          <p:cNvSpPr txBox="1"/>
          <p:nvPr/>
        </p:nvSpPr>
        <p:spPr>
          <a:xfrm>
            <a:off x="4525805" y="9248747"/>
            <a:ext cx="309700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s-ES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80913578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Tema d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52</TotalTime>
  <Words>58</Words>
  <Application>Microsoft Office PowerPoint</Application>
  <PresentationFormat>Panorámica</PresentationFormat>
  <Paragraphs>6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4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ERNESTO MARTÍN</dc:creator>
  <cp:lastModifiedBy>ernesto</cp:lastModifiedBy>
  <cp:revision>4</cp:revision>
  <dcterms:created xsi:type="dcterms:W3CDTF">2023-08-28T19:21:11Z</dcterms:created>
  <dcterms:modified xsi:type="dcterms:W3CDTF">2023-08-29T10:53:42Z</dcterms:modified>
</cp:coreProperties>
</file>